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94"/>
  </p:normalViewPr>
  <p:slideViewPr>
    <p:cSldViewPr snapToGrid="0" snapToObjects="1">
      <p:cViewPr varScale="1">
        <p:scale>
          <a:sx n="115" d="100"/>
          <a:sy n="115" d="100"/>
        </p:scale>
        <p:origin x="472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8AA49B-BB99-3740-A109-B666163895F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9D2F99D-DA91-9A45-9622-00F650D78E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9F2796-A194-3648-8EB2-F3A5CB1AC5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473F933-543E-0C4D-9358-67DDF6E471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6D0354-D29D-2A42-9E52-C2C595AAA6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509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EE6E79-37E1-B041-A6AB-98041F3B37A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2DE4BB2-593A-4F45-BB9F-FF6F3C1133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71E01E-52CE-024A-83B2-0E7B720D9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72E322-9295-5F45-97B4-8C4A0BA31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71E25AB-695F-7D41-A06F-1285EEE61C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8481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00EE4B8-9CB5-B145-B212-3369E9A4950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61AF3B-D352-7B46-BA4C-D385CD783CD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6DAB95-BDA7-894A-B104-AEBE04A743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3BC67D8-D17B-0647-8554-6865FC885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82EFA3-DF7A-1447-9E81-6E069ECE19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90377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B23D03-18DE-4A40-89D8-5909BE3915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CE47DFB-4ABC-544F-B7C6-6C4C3FA2F8F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9A1E68-D5BE-8F49-8B2A-B4A5D9C5F2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EC79A2-516B-A948-8268-9895F4CDB2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92B2C0-15F5-1742-B83D-20F74A863E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23585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2D4B58-B803-6B4E-8BDE-FE10D41C73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E294BAA-A108-404F-9DBE-DC0B33977E9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5CFA55-D032-D84A-BA7D-577B13E648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29FC1E-61F4-5149-8B8B-966151E38E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ECB741-F3A1-644E-8D2F-6C811B8461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765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FB2DB4-BF58-A147-B1A6-75E5E2AA36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759F758-9C09-CB47-AF66-C151E83A4E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1E3636-36B8-1B43-B29E-A87879BE37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41B6FE-30F2-044F-9BC0-E6DEEADF2C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1C308BD-6154-4049-B6E0-2CEBBF6ACD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E110BC-1F85-9445-8908-6EFC7E1CD3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6254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693484-0E0B-CB4A-995F-E0833B32A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25043B-03DF-444D-9834-EED24EFA0A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66FCB0-8AF7-704E-A110-1D6D76FCAD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4E6C52-B358-FD4B-8588-859FBF8016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AFBE772-6745-0F40-B8B3-535129D2CF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9F359EC-CEF0-4F41-BB70-206E383976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6DEB15-CFA8-0F45-8505-5B1EF3D404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8D2D21A-AD57-E046-A85F-FD4EBE06ED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323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8A5DB4-BAE4-6F46-8AA3-ECC6024B4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E30EE5-C410-F54F-8123-66A9874E25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EBA0ABE-DA5D-4547-A2CF-E9F1189FB7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2B7CFFD-759A-6D40-8710-0570F5C2B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8284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9CED697-4E70-1741-AD5B-E33AD2DCF3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8980D07-370E-6E4E-AEA4-A059954304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320AEA1-BDAF-2F48-B4CC-0833AA33FB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03678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348823-E391-FA44-81DC-9F103DBD93F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2023D6-2BB4-4B44-9465-E236494C9CA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6E984A-923D-354A-A62B-8B19BECFC3E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A580DD-6E97-CB43-ABC7-DA4C2F8BE1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D5E48E-7938-FA41-9788-5DA770B1EF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915C559-AA1F-0D41-85BD-4A38D69B56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2914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6BC799-9BF3-524C-BDC8-E7E0F146E5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4A9171E-E8E3-E243-89D3-E10D21F795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7EEAF3-010F-1247-928D-F803990270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B77B17-26CD-594E-AF72-44BDA79446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7C3214-5B5A-A148-9A4F-3225D1039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457CBD3-6498-EB4A-830F-ADBFCCEFDB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3697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C801070-E767-AB46-A760-5EC6260F7E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512DA9-2CDB-A542-A932-10F40C727EB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6EA7DC-0DF4-A443-9866-9C076060CE5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D76352-9715-224D-B8E4-3B17D0B78E74}" type="datetimeFigureOut">
              <a:rPr lang="en-US" smtClean="0"/>
              <a:t>7/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37E22D-7720-CA4C-99A5-3C0F5D0219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674A9A-12EE-DA47-B40A-64E7A966FED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91905C-6E26-5542-A619-63DA52DD25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89259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7CFD751-D666-2C47-8AF2-1DAD7F880B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9809700"/>
              </p:ext>
            </p:extLst>
          </p:nvPr>
        </p:nvGraphicFramePr>
        <p:xfrm>
          <a:off x="3834064" y="91543"/>
          <a:ext cx="4860758" cy="6646142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192762">
                  <a:extLst>
                    <a:ext uri="{9D8B030D-6E8A-4147-A177-3AD203B41FA5}">
                      <a16:colId xmlns:a16="http://schemas.microsoft.com/office/drawing/2014/main" val="2469807167"/>
                    </a:ext>
                  </a:extLst>
                </a:gridCol>
                <a:gridCol w="3667996">
                  <a:extLst>
                    <a:ext uri="{9D8B030D-6E8A-4147-A177-3AD203B41FA5}">
                      <a16:colId xmlns:a16="http://schemas.microsoft.com/office/drawing/2014/main" val="1461787444"/>
                    </a:ext>
                  </a:extLst>
                </a:gridCol>
              </a:tblGrid>
              <a:tr h="217122">
                <a:tc gridSpan="2"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PRIMERS qPCR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4399452"/>
                  </a:ext>
                </a:extLst>
              </a:tr>
              <a:tr h="52164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ALDH1a2 F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GAGTGTTCCCTGTCTGTAATC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89375537"/>
                  </a:ext>
                </a:extLst>
              </a:tr>
              <a:tr h="52164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ALDH1a2 R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CCTTGTCTATATCCACCTTGT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46953739"/>
                  </a:ext>
                </a:extLst>
              </a:tr>
              <a:tr h="52164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ALDH1a3 F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CACGAATCCAAGAGTGGAAG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53361803"/>
                  </a:ext>
                </a:extLst>
              </a:tr>
              <a:tr h="521645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ALDH1a3 R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TCCACATCGGGCTTATCT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75244515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CD44 F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CACAGACCTACCCAATTCCTTC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969753537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CD44 R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TGTGTTCTATACTCGCCCTTC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706720545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DKK3 F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TTCACAAGATAACCAACAACC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509966131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DKK3 R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CTCCTCTTGCCTTCTTCATC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97189212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DLL4 F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TGACCAAGATCTCAACTACTG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24563482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DLL4 R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GAGACAGGTGCAGGTATA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661834520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LGR5 F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ACCTCCGATCTCTGAACTT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487641740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LGR5R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CGACAGGAGATTGGATGATAG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2479542117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Ly6a F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</a:rPr>
                        <a:t>GCAGTTATTGTGGATTCTCAAAC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004338121"/>
                  </a:ext>
                </a:extLst>
              </a:tr>
              <a:tr h="434244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 </a:t>
                      </a:r>
                    </a:p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effectLst/>
                        </a:rPr>
                        <a:t>Ly6a R</a:t>
                      </a:r>
                      <a:endParaRPr lang="en-US" sz="1400" b="1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</a:rPr>
                        <a:t>GTACCCAGGATCTCCATACTT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MS Mincho" panose="02020609040205080304" pitchFamily="49" charset="-128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b"/>
                </a:tc>
                <a:extLst>
                  <a:ext uri="{0D108BD9-81ED-4DB2-BD59-A6C34878D82A}">
                    <a16:rowId xmlns:a16="http://schemas.microsoft.com/office/drawing/2014/main" val="1920910791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211B67E-5736-6948-954A-0DF50060B365}"/>
              </a:ext>
            </a:extLst>
          </p:cNvPr>
          <p:cNvSpPr txBox="1"/>
          <p:nvPr/>
        </p:nvSpPr>
        <p:spPr>
          <a:xfrm>
            <a:off x="211874" y="91543"/>
            <a:ext cx="1052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I</a:t>
            </a:r>
          </a:p>
        </p:txBody>
      </p:sp>
    </p:spTree>
    <p:extLst>
      <p:ext uri="{BB962C8B-B14F-4D97-AF65-F5344CB8AC3E}">
        <p14:creationId xmlns:p14="http://schemas.microsoft.com/office/powerpoint/2010/main" val="3829997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6</TotalTime>
  <Words>66</Words>
  <Application>Microsoft Macintosh PowerPoint</Application>
  <PresentationFormat>Widescreen</PresentationFormat>
  <Paragraphs>5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sso, Angela</dc:creator>
  <cp:lastModifiedBy>Russo, Angela</cp:lastModifiedBy>
  <cp:revision>6</cp:revision>
  <dcterms:created xsi:type="dcterms:W3CDTF">2020-02-11T16:18:42Z</dcterms:created>
  <dcterms:modified xsi:type="dcterms:W3CDTF">2020-07-09T21:08:59Z</dcterms:modified>
</cp:coreProperties>
</file>